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9" autoAdjust="0"/>
    <p:restoredTop sz="94660"/>
  </p:normalViewPr>
  <p:slideViewPr>
    <p:cSldViewPr snapToGrid="0">
      <p:cViewPr varScale="1">
        <p:scale>
          <a:sx n="37" d="100"/>
          <a:sy n="37" d="100"/>
        </p:scale>
        <p:origin x="180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4833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67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158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787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433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382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028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207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337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675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618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450D0-5C18-406C-ADE9-2872AC971F3A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C35AD-65A9-43ED-82A1-D761E4E850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959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773150" y="861352"/>
          <a:ext cx="9096714" cy="2656119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2320246">
                  <a:extLst>
                    <a:ext uri="{9D8B030D-6E8A-4147-A177-3AD203B41FA5}">
                      <a16:colId xmlns:a16="http://schemas.microsoft.com/office/drawing/2014/main" val="1205594758"/>
                    </a:ext>
                  </a:extLst>
                </a:gridCol>
                <a:gridCol w="1038432">
                  <a:extLst>
                    <a:ext uri="{9D8B030D-6E8A-4147-A177-3AD203B41FA5}">
                      <a16:colId xmlns:a16="http://schemas.microsoft.com/office/drawing/2014/main" val="2563052298"/>
                    </a:ext>
                  </a:extLst>
                </a:gridCol>
                <a:gridCol w="1341307">
                  <a:extLst>
                    <a:ext uri="{9D8B030D-6E8A-4147-A177-3AD203B41FA5}">
                      <a16:colId xmlns:a16="http://schemas.microsoft.com/office/drawing/2014/main" val="2182235471"/>
                    </a:ext>
                  </a:extLst>
                </a:gridCol>
                <a:gridCol w="1038432">
                  <a:extLst>
                    <a:ext uri="{9D8B030D-6E8A-4147-A177-3AD203B41FA5}">
                      <a16:colId xmlns:a16="http://schemas.microsoft.com/office/drawing/2014/main" val="1690319966"/>
                    </a:ext>
                  </a:extLst>
                </a:gridCol>
                <a:gridCol w="1038432">
                  <a:extLst>
                    <a:ext uri="{9D8B030D-6E8A-4147-A177-3AD203B41FA5}">
                      <a16:colId xmlns:a16="http://schemas.microsoft.com/office/drawing/2014/main" val="3756459164"/>
                    </a:ext>
                  </a:extLst>
                </a:gridCol>
                <a:gridCol w="1396038">
                  <a:extLst>
                    <a:ext uri="{9D8B030D-6E8A-4147-A177-3AD203B41FA5}">
                      <a16:colId xmlns:a16="http://schemas.microsoft.com/office/drawing/2014/main" val="2477645538"/>
                    </a:ext>
                  </a:extLst>
                </a:gridCol>
                <a:gridCol w="923827">
                  <a:extLst>
                    <a:ext uri="{9D8B030D-6E8A-4147-A177-3AD203B41FA5}">
                      <a16:colId xmlns:a16="http://schemas.microsoft.com/office/drawing/2014/main" val="93265747"/>
                    </a:ext>
                  </a:extLst>
                </a:gridCol>
              </a:tblGrid>
              <a:tr h="50665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 err="1" smtClean="0">
                          <a:effectLst/>
                        </a:rPr>
                        <a:t>Elastography</a:t>
                      </a:r>
                      <a:r>
                        <a:rPr lang="en-US" sz="1400" b="1" u="none" strike="noStrike" dirty="0" smtClean="0">
                          <a:effectLst/>
                        </a:rPr>
                        <a:t> by SWE (n=53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 smtClean="0">
                          <a:effectLst/>
                        </a:rPr>
                        <a:t>FIB-4 (&lt;1.3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 smtClean="0">
                          <a:effectLst/>
                        </a:rPr>
                        <a:t>FIB-4 ( 1.3-3.25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 smtClean="0">
                          <a:effectLst/>
                        </a:rPr>
                        <a:t>FIB-4 ( </a:t>
                      </a:r>
                      <a:r>
                        <a:rPr lang="en-US" sz="1400" b="1" u="none" strike="noStrike" dirty="0">
                          <a:effectLst/>
                        </a:rPr>
                        <a:t>&gt;</a:t>
                      </a:r>
                      <a:r>
                        <a:rPr lang="en-US" sz="1400" b="1" u="none" strike="noStrike" dirty="0" smtClean="0">
                          <a:effectLst/>
                        </a:rPr>
                        <a:t>1.3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 smtClean="0">
                          <a:effectLst/>
                        </a:rPr>
                        <a:t>NFS&lt;(-0.455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 smtClean="0">
                          <a:effectLst/>
                        </a:rPr>
                        <a:t>NFS (-0.455-0.675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>
                          <a:effectLst/>
                        </a:rPr>
                        <a:t>NFS</a:t>
                      </a:r>
                      <a:r>
                        <a:rPr lang="en-US" sz="1400" b="1" u="none" strike="noStrike" dirty="0" smtClean="0">
                          <a:effectLst/>
                        </a:rPr>
                        <a:t>&gt;(0.675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66056064"/>
                  </a:ext>
                </a:extLst>
              </a:tr>
              <a:tr h="3070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SWE&lt;5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(3.8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5(28.3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(9.4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7(13.2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15(28.3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17438838"/>
                  </a:ext>
                </a:extLst>
              </a:tr>
              <a:tr h="3070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5&lt;SWE&lt;12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(5.7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2(41.5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(1.9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3(5.7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23(43.4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90066407"/>
                  </a:ext>
                </a:extLst>
              </a:tr>
              <a:tr h="3070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SWE&gt;12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(3.8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(5.7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(3.8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3(5.7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45446404"/>
                  </a:ext>
                </a:extLst>
              </a:tr>
              <a:tr h="3070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 err="1" smtClean="0">
                          <a:effectLst/>
                        </a:rPr>
                        <a:t>Elastography</a:t>
                      </a:r>
                      <a:r>
                        <a:rPr lang="en-US" sz="1400" b="1" u="none" strike="noStrike" dirty="0" smtClean="0">
                          <a:effectLst/>
                        </a:rPr>
                        <a:t> by TE (n=23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 smtClean="0">
                          <a:effectLst/>
                        </a:rPr>
                        <a:t>FIB-4 (&lt;1.3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 smtClean="0">
                          <a:effectLst/>
                        </a:rPr>
                        <a:t>FIB-4 ( 1.3-3.25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 smtClean="0">
                          <a:effectLst/>
                        </a:rPr>
                        <a:t>FIB-4 ( </a:t>
                      </a:r>
                      <a:r>
                        <a:rPr lang="en-US" sz="1400" b="1" u="none" strike="noStrike" dirty="0">
                          <a:effectLst/>
                        </a:rPr>
                        <a:t>&gt;</a:t>
                      </a:r>
                      <a:r>
                        <a:rPr lang="en-US" sz="1400" b="1" u="none" strike="noStrike" dirty="0" smtClean="0">
                          <a:effectLst/>
                        </a:rPr>
                        <a:t>1.3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 smtClean="0">
                          <a:effectLst/>
                        </a:rPr>
                        <a:t>NFS&lt;(-0.455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 smtClean="0">
                          <a:effectLst/>
                        </a:rPr>
                        <a:t>NFS (-0.455-0.675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u="none" strike="noStrike" dirty="0">
                          <a:effectLst/>
                        </a:rPr>
                        <a:t>NFS</a:t>
                      </a:r>
                      <a:r>
                        <a:rPr lang="en-US" sz="1400" b="1" u="none" strike="noStrike" dirty="0" smtClean="0">
                          <a:effectLst/>
                        </a:rPr>
                        <a:t>&gt;(0.675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01010203"/>
                  </a:ext>
                </a:extLst>
              </a:tr>
              <a:tr h="3070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TE&lt;5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(4.3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(4.3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(4.3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1(4.3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1645037"/>
                  </a:ext>
                </a:extLst>
              </a:tr>
              <a:tr h="3070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5&lt;TE&lt;12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(8.7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4(60.9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4(17.4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2(52.2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45304237"/>
                  </a:ext>
                </a:extLst>
              </a:tr>
              <a:tr h="3070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TE&gt;12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(4.3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(13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(4.3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(4.3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4(17.4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38246850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773150" y="3706821"/>
            <a:ext cx="755642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ea typeface="Arial" panose="020B0604020202020204" pitchFamily="34" charset="0"/>
                <a:cs typeface="Arial" panose="020B0604020202020204" pitchFamily="34" charset="0"/>
              </a:rPr>
              <a:t>Data are presented n (%).</a:t>
            </a:r>
            <a:r>
              <a:rPr lang="en-US" altLang="en-US" sz="1400" dirty="0" smtClean="0">
                <a:ea typeface="Arial" panose="020B0604020202020204" pitchFamily="34" charset="0"/>
                <a:cs typeface="Arial" panose="020B0604020202020204" pitchFamily="34" charset="0"/>
              </a:rPr>
              <a:t>NFS; </a:t>
            </a:r>
            <a:r>
              <a:rPr lang="en-US" sz="1400" dirty="0"/>
              <a:t>NAFLD </a:t>
            </a:r>
            <a:r>
              <a:rPr lang="en-US" sz="1400" dirty="0" smtClean="0"/>
              <a:t>score, SWE; shear wave </a:t>
            </a:r>
            <a:r>
              <a:rPr lang="en-US" sz="1400" dirty="0" err="1" smtClean="0"/>
              <a:t>elastography</a:t>
            </a:r>
            <a:r>
              <a:rPr lang="en-US" sz="1400" dirty="0" smtClean="0"/>
              <a:t>, TE; transient </a:t>
            </a:r>
            <a:r>
              <a:rPr lang="en-US" sz="1400" dirty="0" err="1" smtClean="0"/>
              <a:t>elastography</a:t>
            </a:r>
            <a:endParaRPr lang="en-US" altLang="en-US" sz="1400" dirty="0"/>
          </a:p>
        </p:txBody>
      </p:sp>
      <p:sp>
        <p:nvSpPr>
          <p:cNvPr id="4" name="Rectangle 3"/>
          <p:cNvSpPr/>
          <p:nvPr/>
        </p:nvSpPr>
        <p:spPr>
          <a:xfrm>
            <a:off x="773150" y="302670"/>
            <a:ext cx="861594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 table 2</a:t>
            </a:r>
            <a:r>
              <a:rPr lang="en-US" dirty="0" smtClean="0"/>
              <a:t>: </a:t>
            </a:r>
            <a:r>
              <a:rPr lang="en-US" altLang="en-US" dirty="0">
                <a:ea typeface="Arial" panose="020B0604020202020204" pitchFamily="34" charset="0"/>
                <a:cs typeface="Arial" panose="020B0604020202020204" pitchFamily="34" charset="0"/>
              </a:rPr>
              <a:t>Categorizing</a:t>
            </a:r>
            <a:r>
              <a:rPr lang="en-US" dirty="0" smtClean="0"/>
              <a:t> </a:t>
            </a:r>
            <a:r>
              <a:rPr lang="en-US" dirty="0"/>
              <a:t>participants according to SWE and TE </a:t>
            </a:r>
            <a:r>
              <a:rPr lang="en-US" dirty="0" smtClean="0"/>
              <a:t>individuall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96686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3</Words>
  <Application>Microsoft Office PowerPoint</Application>
  <PresentationFormat>Widescreen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</cp:revision>
  <dcterms:created xsi:type="dcterms:W3CDTF">2023-11-01T06:37:47Z</dcterms:created>
  <dcterms:modified xsi:type="dcterms:W3CDTF">2023-11-01T06:38:06Z</dcterms:modified>
</cp:coreProperties>
</file>